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FFEEB-4CE2-4FDA-8135-7809D74866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294A9-C93A-41EC-9532-4BB3235D66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9E86A-C165-4848-8EAF-DEC58065CC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0BEB4-1213-4C31-8C13-3965DE4BCA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1D0D7-8AD4-4397-9512-E0D69574B7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9B449-9540-472E-B4BC-12C67A1242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B98C6-046B-454C-BD29-6B782D91D3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C19D5-D7C3-4151-A24E-AD0B7173BE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1F617-E955-46E0-80A9-8F1EA3F94E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48335-6E77-42D5-A872-A146470099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FEC44-3881-4FA8-914A-5739162744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66E1C0-3CB5-4787-B0BA-D621614CEC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DC2441-F8B4-48AF-8250-2CCB6C23537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763640" y="1396800"/>
            <a:ext cx="6382440" cy="3703680"/>
            <a:chOff x="1763640" y="1396800"/>
            <a:chExt cx="6382440" cy="370368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1763640" y="1787400"/>
              <a:ext cx="4602240" cy="331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ZoneTexte 8"/>
            <p:cNvSpPr/>
            <p:nvPr/>
          </p:nvSpPr>
          <p:spPr>
            <a:xfrm>
              <a:off x="1967040" y="1413000"/>
              <a:ext cx="1236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% of similarit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"/>
            <p:cNvGrpSpPr/>
            <p:nvPr/>
          </p:nvGrpSpPr>
          <p:grpSpPr>
            <a:xfrm>
              <a:off x="6438600" y="1635120"/>
              <a:ext cx="1707480" cy="3243600"/>
              <a:chOff x="6438600" y="1635120"/>
              <a:chExt cx="1707480" cy="3243600"/>
            </a:xfrm>
          </p:grpSpPr>
          <p:sp>
            <p:nvSpPr>
              <p:cNvPr id="45" name=""/>
              <p:cNvSpPr/>
              <p:nvPr/>
            </p:nvSpPr>
            <p:spPr>
              <a:xfrm>
                <a:off x="6440040" y="1635120"/>
                <a:ext cx="339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Strai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7074000" y="1635120"/>
                <a:ext cx="773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PFGE patter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6439680" y="1857240"/>
                <a:ext cx="403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JAP18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7294680" y="185580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6440040" y="2041560"/>
                <a:ext cx="416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MCO1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7294320" y="2041560"/>
                <a:ext cx="84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6439680" y="2239920"/>
                <a:ext cx="46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HSM7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7294320" y="2239920"/>
                <a:ext cx="84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439680" y="2428920"/>
                <a:ext cx="48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MCO19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7294680" y="242892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6438600" y="2608200"/>
                <a:ext cx="352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866b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7294320" y="2608200"/>
                <a:ext cx="78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6439320" y="280188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9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7294320" y="280188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6439320" y="300024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54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7294680" y="300024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6439680" y="3195720"/>
                <a:ext cx="46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HSM72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7294680" y="319572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6440040" y="3384720"/>
                <a:ext cx="416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MCO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7313400" y="3381480"/>
                <a:ext cx="43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6439680" y="3573360"/>
                <a:ext cx="39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ITL11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7311960" y="3573360"/>
                <a:ext cx="4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J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6439320" y="3755880"/>
                <a:ext cx="380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654A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7294680" y="375588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6439680" y="3949560"/>
                <a:ext cx="401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6074aé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7294320" y="3946680"/>
                <a:ext cx="78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6439320" y="4140360"/>
                <a:ext cx="345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5162a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7294320" y="413856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6440400" y="4343400"/>
                <a:ext cx="389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AGT4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7294680" y="434340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6440400" y="4527720"/>
                <a:ext cx="387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COB4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7292880" y="452592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6439320" y="472608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7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7294320" y="472428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7991280" y="1636560"/>
                <a:ext cx="15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S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7995600" y="185724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8033760" y="204300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8033760" y="224172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8033760" y="243036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8033760" y="261000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7995600" y="280368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7995600" y="300204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7995600" y="319716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7995600" y="338292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7995600" y="357516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7995600" y="375768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7995600" y="394812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7995600" y="414036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8030520" y="434484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8030520" y="452772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7995600" y="472608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" name=""/>
            <p:cNvSpPr/>
            <p:nvPr/>
          </p:nvSpPr>
          <p:spPr>
            <a:xfrm rot="16200000">
              <a:off x="2833200" y="1538280"/>
              <a:ext cx="495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2463840" y="1536480"/>
              <a:ext cx="495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6200000">
              <a:off x="2065320" y="1536480"/>
              <a:ext cx="495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16200000">
              <a:off x="1685520" y="1538280"/>
              <a:ext cx="495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2T21:10:46Z</dcterms:created>
  <dc:creator>ONS</dc:creator>
  <dc:description/>
  <dc:language>en-US</dc:language>
  <cp:lastModifiedBy>D. Ashley Robinson</cp:lastModifiedBy>
  <dcterms:modified xsi:type="dcterms:W3CDTF">2012-06-21T14:56:43Z</dcterms:modified>
  <cp:revision>6</cp:revision>
  <dc:subject/>
  <dc:title>Diapositive 1</dc:title>
</cp:coreProperties>
</file>